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428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C34B47-6386-4A76-B167-F0D4365222E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0AB7D1-A79E-47F5-9F89-7C69250E7B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43520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0B22355-3C3E-B248-1C77-8A1084A7FD7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4648E58B-4CA5-06F2-8BE6-197DBA684744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18629800-2237-1345-EBFD-42E3CF58A7FB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ja-JP" altLang="en-US" dirty="0"/>
              <a:t>マススペクトリミー依頼</a:t>
            </a:r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E669FC6-858D-DC9F-A40C-5D3E755A794B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0AB7D1-A79E-47F5-9F89-7C69250E7B2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19840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22850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57823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46498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36783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16169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90261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3946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96224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46221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77340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93232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11524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E1E1D2A-0EC5-1371-2FF9-ACAD29D27CA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図 19">
            <a:extLst>
              <a:ext uri="{FF2B5EF4-FFF2-40B4-BE49-F238E27FC236}">
                <a16:creationId xmlns:a16="http://schemas.microsoft.com/office/drawing/2014/main" id="{52DDB1AE-1345-ACDC-F7E0-F247F1C1488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68253" y="3551776"/>
            <a:ext cx="3896036" cy="2802448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D74E5FF1-A9E9-E53B-BC79-5DBD88D09FC4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393555" y="1068337"/>
            <a:ext cx="5201920" cy="2028190"/>
          </a:xfrm>
          <a:prstGeom prst="rect">
            <a:avLst/>
          </a:prstGeom>
          <a:noFill/>
          <a:ln>
            <a:noFill/>
          </a:ln>
        </p:spPr>
      </p:pic>
      <p:cxnSp>
        <p:nvCxnSpPr>
          <p:cNvPr id="2" name="直線矢印コネクタ 1">
            <a:extLst>
              <a:ext uri="{FF2B5EF4-FFF2-40B4-BE49-F238E27FC236}">
                <a16:creationId xmlns:a16="http://schemas.microsoft.com/office/drawing/2014/main" id="{4E6B61F7-9DC3-2193-8DE8-1DFD485A5F8D}"/>
              </a:ext>
            </a:extLst>
          </p:cNvPr>
          <p:cNvCxnSpPr/>
          <p:nvPr/>
        </p:nvCxnSpPr>
        <p:spPr>
          <a:xfrm>
            <a:off x="1693121" y="875692"/>
            <a:ext cx="0" cy="662152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E194B65-3741-88EF-E33E-7F3BBE337858}"/>
              </a:ext>
            </a:extLst>
          </p:cNvPr>
          <p:cNvSpPr txBox="1"/>
          <p:nvPr/>
        </p:nvSpPr>
        <p:spPr>
          <a:xfrm>
            <a:off x="207818" y="152400"/>
            <a:ext cx="28598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FA0FD0D-6BA7-A4D2-234B-3B4A6305A84A}"/>
              </a:ext>
            </a:extLst>
          </p:cNvPr>
          <p:cNvSpPr txBox="1"/>
          <p:nvPr/>
        </p:nvSpPr>
        <p:spPr>
          <a:xfrm>
            <a:off x="409817" y="532085"/>
            <a:ext cx="4722622" cy="64633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2529E27-7468-493F-84C0-F4EF12FF3E20}"/>
              </a:ext>
            </a:extLst>
          </p:cNvPr>
          <p:cNvSpPr txBox="1"/>
          <p:nvPr/>
        </p:nvSpPr>
        <p:spPr>
          <a:xfrm>
            <a:off x="296053" y="8311400"/>
            <a:ext cx="645967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 Structural characterization of the fucose-conjugated boron compound (fucose-BSH).</a:t>
            </a:r>
            <a:b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A) Proton nuclear magnetic resonance (^1H NMR) spectrum of (fucose triacetate)-¹⁰BSH conjugate 2 in D₂O.</a:t>
            </a:r>
            <a:b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B) Infrared (IR) spectrum of (fucose triacetate)-¹⁰BSH conjugate 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583290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5731</TotalTime>
  <Words>71</Words>
  <Application>Microsoft Office PowerPoint</Application>
  <PresentationFormat>A4 210 x 297 mm</PresentationFormat>
  <Paragraphs>2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金平 典之</dc:creator>
  <cp:lastModifiedBy>道上 宏之</cp:lastModifiedBy>
  <cp:revision>192</cp:revision>
  <dcterms:created xsi:type="dcterms:W3CDTF">2022-06-29T03:55:00Z</dcterms:created>
  <dcterms:modified xsi:type="dcterms:W3CDTF">2025-08-06T07:06:27Z</dcterms:modified>
</cp:coreProperties>
</file>